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4" autoAdjust="0"/>
    <p:restoredTop sz="94660"/>
  </p:normalViewPr>
  <p:slideViewPr>
    <p:cSldViewPr snapToGrid="0">
      <p:cViewPr varScale="1">
        <p:scale>
          <a:sx n="77" d="100"/>
          <a:sy n="77" d="100"/>
        </p:scale>
        <p:origin x="1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974AC-5CB8-A76B-683C-BF54D61A4D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AF31B6-27E6-D6A7-0DC8-4DF58C2D9A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F7E3CE-3C7B-AABC-E249-E1C410183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8A5EF6-15F1-108F-2EDD-DFE69489A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07B3A2-2179-4A9F-C60C-F7E086854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089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F8952-EA53-2511-AAA8-3ADA46E3E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B31DB0-57FB-4C8C-DF8E-DB5CF50E43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85714D-04F8-50E4-B68F-EB38ABDC0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785067-8F80-8E3B-263C-B5513632A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A79EC3-0268-DE50-746D-85BD9B757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34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69B352-AB50-F983-4F36-5753D82CDB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92C372-0CCD-9C1D-A7AE-24B40F9AB2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FACA7-5948-6250-865D-30FAF184C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E24FDE-934B-6C9F-FA6B-A766CAC92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7FB2C6-0C7E-597C-F894-9181F19B4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7380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12044F-E747-1519-BC38-C584C11FB8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8396F7-9F11-1938-0BB8-1CD8508AFB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F73798-0724-CEB7-2554-F0C6F120B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4C2BF1-1621-1DB6-31A6-2BCBA6930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59D144-19AB-E5F0-0071-A2EA337CF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703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4D539-D346-3BD1-66DA-E3772FFFD4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9177CE-CDF7-B91B-5F27-E73967075E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57D2D-01AE-B137-D335-B5F799DCE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866F4F-0A9B-035F-B9D7-8C1B236BE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8E8EDD-B30F-E9BC-8F58-F5C5FF2FC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76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934CA1-F6C0-D328-A51C-A965D69392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252A30-3715-5D92-B8FE-596F159AA3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545441-A2A7-C8CF-DA79-8B8EFE2CFD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8A8507-363D-7A35-EA3A-9515035D1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F50BBF-046E-FB50-06DF-883570531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920C63-0CDA-B130-8282-4219723000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774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C8AE1-B533-703A-86EB-D2619DFE3F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0C61E6-DBAA-0930-6641-CBB56F302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C3FED2-0F7A-0BA8-C4C5-77479F4DDD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EAE560-F081-5D25-3DFB-2F665C1F9A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D4087AC-3EC0-DCF9-7092-359775D280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6322720-0CB9-B6F3-31CB-254F15B8A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AFF30C-FD8D-D2D1-3C7A-6656C3F143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F3DF34-0FB7-958D-893D-12E5D3D3D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455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DE8E1-7E6F-2F5E-F7D0-5F6CE1A30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3B95F9-2525-37E4-990E-E03746CFF1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6C7AFC-B07D-A0C5-76CE-3FD2FFD9D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1F293B-9F70-E2F3-D374-7A7E356B6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051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9CCEDE-F178-3BC8-B3CE-DA40AEF83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9CD3ABF-A2F9-B827-375A-BDE79D450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1DA4BA9-C93A-EA3B-EE0F-5AC3E3235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670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B65ACE-6005-C0F8-3F70-3462E00B64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80D214-6866-94A9-CD8C-95BB215812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BD2C36-7D7E-0460-BFD4-F3F4F05313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3DC226-6808-6102-9ECA-89ABACA239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347750-7AD3-FCCD-0A4B-7AC2E5E26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9EEBA8-E260-F6EE-7FEB-67A14DC83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056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0DE8D-9FCB-F818-7BCE-EC8001BCA9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0F2867-F9BB-ACF3-964E-4429993E1C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4200A3-88F9-77BA-316D-7160DB5641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A8FBF5-4C2F-1CD0-4A5B-DF542FFE3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520463-68B3-8086-0C29-F731A84EB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98ECCE-E294-BE6C-E280-E7BE9EAD5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174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59CD53-319E-22BD-D243-CB79EB5685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345C54-79F5-BFF3-ABCA-1D3FB914B9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4978C-EB4F-5306-27B8-2852047007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075A64-B600-4BF3-BCB4-770BA0B1E7F6}" type="datetimeFigureOut">
              <a:rPr lang="en-US" smtClean="0"/>
              <a:t>3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0079C4-1EE3-73F8-137D-C329124787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5C6A4C-E285-D234-1A61-D936CFE709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035FF-EA13-4743-B321-E208DDA9E6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990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8" descr="C:\Users\Kersey\Downloads\PDQ-39 Subset LINE Graphs - No Legend 4.10.17.PNG">
            <a:extLst>
              <a:ext uri="{FF2B5EF4-FFF2-40B4-BE49-F238E27FC236}">
                <a16:creationId xmlns:a16="http://schemas.microsoft.com/office/drawing/2014/main" id="{DAF5076F-150D-7CB0-586F-920A4175992C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173982" y="643466"/>
            <a:ext cx="3844035" cy="5571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9" descr="C:\Users\Kersey\Downloads\Other Graphs and PDQ-39 legend - version 1.PNG">
            <a:extLst>
              <a:ext uri="{FF2B5EF4-FFF2-40B4-BE49-F238E27FC236}">
                <a16:creationId xmlns:a16="http://schemas.microsoft.com/office/drawing/2014/main" id="{0D7A69DC-6CAE-1BD1-AE9D-D208CD9E21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3982" y="306899"/>
            <a:ext cx="3721291" cy="3365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AF85A2A-67A7-3A66-C66D-2E77878C3896}"/>
              </a:ext>
            </a:extLst>
          </p:cNvPr>
          <p:cNvSpPr txBox="1"/>
          <p:nvPr/>
        </p:nvSpPr>
        <p:spPr>
          <a:xfrm>
            <a:off x="8018017" y="4191333"/>
            <a:ext cx="3721291" cy="21929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u="sng" dirty="0">
                <a:latin typeface="Arial" panose="020B0604020202020204" pitchFamily="34" charset="0"/>
                <a:cs typeface="Arial" panose="020B0604020202020204" pitchFamily="34" charset="0"/>
              </a:rPr>
              <a:t>Figure S1. Pre-, Post-, and 1-Month Post-Test Parkinson’s Disease Questionnaire-39 (PDQ-39) Summary Index and Subscale Scores. </a:t>
            </a:r>
          </a:p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Performance of IG (warm colors) and EG participants (cool colors) on the PDQ-39 Summary Index (A), and Mobility (B), Emotional Well-Being (C), Bodily Discomfort (D), Communication (E), Stigma (F), Cognition (G), Social Support (H), and Activities of Daily Living (I) Subscales. Lower scores indicate better PD-specific health-related QOL in the previous month. Most participants indicated improved PD-related Stigma (F) and ADLs (I), but worse Communication (E). Some participants’ self-reported health-related QOL was more impacted than others.</a:t>
            </a:r>
          </a:p>
        </p:txBody>
      </p:sp>
    </p:spTree>
    <p:extLst>
      <p:ext uri="{BB962C8B-B14F-4D97-AF65-F5344CB8AC3E}">
        <p14:creationId xmlns:p14="http://schemas.microsoft.com/office/powerpoint/2010/main" val="2498950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13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ckney, Madeleine E.</dc:creator>
  <cp:lastModifiedBy>Joyce Adjekum-Tolno</cp:lastModifiedBy>
  <cp:revision>2</cp:revision>
  <dcterms:created xsi:type="dcterms:W3CDTF">2024-03-05T19:32:37Z</dcterms:created>
  <dcterms:modified xsi:type="dcterms:W3CDTF">2024-03-20T09:58:06Z</dcterms:modified>
</cp:coreProperties>
</file>